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26A09-D01F-433C-9145-EDCFD2BBD4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502725-A38C-4D0B-90F8-D9627FA9F8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BD928-48B2-4744-BF1A-81B6DC0690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17AB55-4791-4FD0-8C6D-A1926D585C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79F56-FC3E-4A24-8BA6-CB799FC38D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2CB94-9851-4B4D-9FA7-9343530C1C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00CC6-63E7-4C81-B3AD-82D31DDCD5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271046-F13E-40C2-BC09-D6E08C3F5A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86A789-F012-49FF-AA27-020D2A092F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A94D3-1D48-4F9D-8F66-29A2D15766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071C5-F7E6-47FF-8E62-459F9639B5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D30F37-73C4-47D5-B485-858B3BF099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4543CED-CD5E-48BB-B4F3-AF99BFCA2155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706A1C7-7EDA-4BAC-A165-4D412EC4D29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1" descr="tunicmycin.png"/>
          <p:cNvPicPr/>
          <p:nvPr/>
        </p:nvPicPr>
        <p:blipFill>
          <a:blip r:embed="rId1"/>
          <a:stretch/>
        </p:blipFill>
        <p:spPr>
          <a:xfrm>
            <a:off x="181080" y="565200"/>
            <a:ext cx="2293920" cy="22953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0" descr="tunic.png"/>
          <p:cNvPicPr/>
          <p:nvPr/>
        </p:nvPicPr>
        <p:blipFill>
          <a:blip r:embed="rId2"/>
          <a:stretch/>
        </p:blipFill>
        <p:spPr>
          <a:xfrm>
            <a:off x="111240" y="4594320"/>
            <a:ext cx="2579400" cy="2579760"/>
          </a:xfrm>
          <a:prstGeom prst="rect">
            <a:avLst/>
          </a:prstGeom>
          <a:ln w="0">
            <a:noFill/>
          </a:ln>
        </p:spPr>
      </p:pic>
      <p:grpSp>
        <p:nvGrpSpPr>
          <p:cNvPr id="43" name="Group 27"/>
          <p:cNvGrpSpPr/>
          <p:nvPr/>
        </p:nvGrpSpPr>
        <p:grpSpPr>
          <a:xfrm>
            <a:off x="0" y="200160"/>
            <a:ext cx="2548080" cy="4908240"/>
            <a:chOff x="0" y="200160"/>
            <a:chExt cx="2548080" cy="4908240"/>
          </a:xfrm>
        </p:grpSpPr>
        <p:pic>
          <p:nvPicPr>
            <p:cNvPr id="44" name="Picture 28" descr="Tunicamycin.png"/>
            <p:cNvPicPr/>
            <p:nvPr/>
          </p:nvPicPr>
          <p:blipFill>
            <a:blip r:embed="rId3"/>
            <a:stretch/>
          </p:blipFill>
          <p:spPr>
            <a:xfrm>
              <a:off x="0" y="2649960"/>
              <a:ext cx="2548080" cy="245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Box 29"/>
            <p:cNvSpPr/>
            <p:nvPr/>
          </p:nvSpPr>
          <p:spPr>
            <a:xfrm>
              <a:off x="457200" y="200160"/>
              <a:ext cx="1652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Tunicamyci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" name="TextBox 7"/>
          <p:cNvSpPr/>
          <p:nvPr/>
        </p:nvSpPr>
        <p:spPr>
          <a:xfrm>
            <a:off x="5843520" y="1649520"/>
            <a:ext cx="273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Dnf2 (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spholipids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5843520" y="4572000"/>
            <a:ext cx="311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ca1 (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admium, copper, iron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5843520" y="3111480"/>
            <a:ext cx="2103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ho89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phosphate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5843520" y="6033960"/>
            <a:ext cx="236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Qdr2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Multiple drugs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0" name="Straight Arrow Connector 11"/>
          <p:cNvCxnSpPr>
            <a:endCxn id="51" idx="1"/>
          </p:cNvCxnSpPr>
          <p:nvPr/>
        </p:nvCxnSpPr>
        <p:spPr>
          <a:xfrm flipV="1">
            <a:off x="2548080" y="372960"/>
            <a:ext cx="3295800" cy="350532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52" name="Straight Arrow Connector 12"/>
          <p:cNvCxnSpPr>
            <a:endCxn id="49" idx="1"/>
          </p:cNvCxnSpPr>
          <p:nvPr/>
        </p:nvCxnSpPr>
        <p:spPr>
          <a:xfrm>
            <a:off x="2548080" y="3878280"/>
            <a:ext cx="3295800" cy="23400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53" name="Straight Arrow Connector 13"/>
          <p:cNvCxnSpPr>
            <a:endCxn id="48" idx="1"/>
          </p:cNvCxnSpPr>
          <p:nvPr/>
        </p:nvCxnSpPr>
        <p:spPr>
          <a:xfrm flipV="1">
            <a:off x="2548080" y="3295440"/>
            <a:ext cx="3295800" cy="583200"/>
          </a:xfrm>
          <a:prstGeom prst="straightConnector1">
            <a:avLst/>
          </a:prstGeom>
          <a:ln w="25560">
            <a:solidFill>
              <a:srgbClr val="4f81bd"/>
            </a:solidFill>
            <a:prstDash val="dash"/>
            <a:miter/>
            <a:tailEnd len="med" type="arrow" w="med"/>
          </a:ln>
        </p:spPr>
      </p:cxnSp>
      <p:cxnSp>
        <p:nvCxnSpPr>
          <p:cNvPr id="54" name="Straight Arrow Connector 14"/>
          <p:cNvCxnSpPr>
            <a:endCxn id="46" idx="1"/>
          </p:cNvCxnSpPr>
          <p:nvPr/>
        </p:nvCxnSpPr>
        <p:spPr>
          <a:xfrm flipV="1">
            <a:off x="2548080" y="1833480"/>
            <a:ext cx="3295800" cy="20448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55" name="Straight Arrow Connector 15"/>
          <p:cNvCxnSpPr>
            <a:endCxn id="47" idx="1"/>
          </p:cNvCxnSpPr>
          <p:nvPr/>
        </p:nvCxnSpPr>
        <p:spPr>
          <a:xfrm>
            <a:off x="2548080" y="3877920"/>
            <a:ext cx="3295800" cy="878400"/>
          </a:xfrm>
          <a:prstGeom prst="straightConnector1">
            <a:avLst/>
          </a:prstGeom>
          <a:ln w="25560">
            <a:solidFill>
              <a:srgbClr val="4f81bd"/>
            </a:solidFill>
            <a:prstDash val="dash"/>
            <a:miter/>
            <a:tailEnd len="med" type="arrow" w="med"/>
          </a:ln>
        </p:spPr>
      </p:cxnSp>
      <p:sp>
        <p:nvSpPr>
          <p:cNvPr id="51" name="TextBox 42"/>
          <p:cNvSpPr/>
          <p:nvPr/>
        </p:nvSpPr>
        <p:spPr>
          <a:xfrm>
            <a:off x="5843520" y="189000"/>
            <a:ext cx="305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Lem3 (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hospholipids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6T08:16:23Z</dcterms:created>
  <dc:creator>Elizabeth Bilsland</dc:creator>
  <dc:description/>
  <dc:language>en-US</dc:language>
  <cp:lastModifiedBy>Elizabeth Bilsland</cp:lastModifiedBy>
  <dcterms:modified xsi:type="dcterms:W3CDTF">2011-09-08T14:03:27Z</dcterms:modified>
  <cp:revision>2</cp:revision>
  <dc:subject/>
  <dc:title>Slide 1</dc:title>
</cp:coreProperties>
</file>